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7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embeddings/oleObject5.xlsx" ContentType="application/vnd.openxmlformats-officedocument.spreadsheetml.sheet"/>
  <Override PartName="/ppt/embeddings/oleObject6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8121650" cy="16203613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4C7D1A-0B90-40F8-B4BA-26A07F24876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730728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06440" y="9365760"/>
            <a:ext cx="730728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702E19-AA85-4630-A9EE-E90D591682B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150800" y="378108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06440" y="936576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150800" y="936576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4EC7AD-76A6-4746-9E57-6A52AC2BD3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23526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877120" y="3781080"/>
            <a:ext cx="23526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347800" y="3781080"/>
            <a:ext cx="23526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06440" y="9365760"/>
            <a:ext cx="23526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877120" y="9365760"/>
            <a:ext cx="23526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347800" y="9365760"/>
            <a:ext cx="23526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62AD1F-8D4D-4485-B9B0-FA08005F1A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06440" y="3781080"/>
            <a:ext cx="7307280" cy="10691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5B071A-83EB-4BE6-B6C1-2E253E6AD4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7307280" cy="1069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278DD6-B971-4B06-9E2E-98E489A6513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3565800" cy="1069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150800" y="3781080"/>
            <a:ext cx="3565800" cy="1069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78F6B3-AD4A-4597-B32B-BB4D78AD78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28C3F0-83D6-4725-B060-08E7EDB40B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06440" y="649080"/>
            <a:ext cx="7307280" cy="12518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465357-002A-4FC3-8E69-E772A7FC9D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150800" y="3781080"/>
            <a:ext cx="3565800" cy="1069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06440" y="936576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6E9A13-6077-447A-A020-77D50745B4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3565800" cy="1069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150800" y="378108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150800" y="936576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FA7F15-5355-42C1-AC34-BEDD401F31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150800" y="378108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06440" y="9365760"/>
            <a:ext cx="730728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88E0F6-403E-4889-8513-7231E7279E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06440" y="3781080"/>
            <a:ext cx="7307280" cy="1069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06080" y="14755680"/>
            <a:ext cx="1893960" cy="112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774880" y="14755680"/>
            <a:ext cx="2570400" cy="112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819400" y="14755680"/>
            <a:ext cx="1893960" cy="112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4033FAD-8487-4582-BB16-855F848E2704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package" Target="../embeddings/oleObject4.xlsx"/><Relationship Id="rId8" Type="http://schemas.openxmlformats.org/officeDocument/2006/relationships/image" Target="../media/image4.wmf"/><Relationship Id="rId9" Type="http://schemas.openxmlformats.org/officeDocument/2006/relationships/package" Target="../embeddings/oleObject5.xlsx"/><Relationship Id="rId10" Type="http://schemas.openxmlformats.org/officeDocument/2006/relationships/image" Target="../media/image5.wmf"/><Relationship Id="rId11" Type="http://schemas.openxmlformats.org/officeDocument/2006/relationships/package" Target="../embeddings/oleObject6.xlsx"/><Relationship Id="rId12" Type="http://schemas.openxmlformats.org/officeDocument/2006/relationships/image" Target="../media/image6.wmf"/><Relationship Id="rId13" Type="http://schemas.openxmlformats.org/officeDocument/2006/relationships/package" Target="../embeddings/oleObject7.xlsx"/><Relationship Id="rId14" Type="http://schemas.openxmlformats.org/officeDocument/2006/relationships/image" Target="../media/image7.wmf"/><Relationship Id="rId15" Type="http://schemas.openxmlformats.org/officeDocument/2006/relationships/slideLayout" Target="../slideLayouts/slideLayout1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723960" y="10045800"/>
          <a:ext cx="6805440" cy="10062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23960" y="10045800"/>
                    <a:ext cx="6805440" cy="1006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819000" y="9180360"/>
          <a:ext cx="6697800" cy="100656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819000" y="9180360"/>
                    <a:ext cx="6697800" cy="1006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727200" y="8245440"/>
          <a:ext cx="6767280" cy="100656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727200" y="8245440"/>
                    <a:ext cx="6767280" cy="1006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"/>
          <p:cNvGraphicFramePr/>
          <p:nvPr/>
        </p:nvGraphicFramePr>
        <p:xfrm>
          <a:off x="831960" y="7308720"/>
          <a:ext cx="6651360" cy="100512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831960" y="7308720"/>
                    <a:ext cx="6651360" cy="1005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9" name=""/>
          <p:cNvGraphicFramePr/>
          <p:nvPr/>
        </p:nvGraphicFramePr>
        <p:xfrm>
          <a:off x="819000" y="5364000"/>
          <a:ext cx="6697800" cy="989280"/>
        </p:xfrm>
        <a:graphic>
          <a:graphicData uri="http://schemas.openxmlformats.org/presentationml/2006/ole">
            <p:oleObj progId="Excel.Sheet.12" r:id="rId9" spid="">
              <p:embed/>
              <p:pic>
                <p:nvPicPr>
                  <p:cNvPr id="50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819000" y="5364000"/>
                    <a:ext cx="6697800" cy="989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1" name=""/>
          <p:cNvGraphicFramePr/>
          <p:nvPr/>
        </p:nvGraphicFramePr>
        <p:xfrm>
          <a:off x="727200" y="6372360"/>
          <a:ext cx="6802200" cy="979200"/>
        </p:xfrm>
        <a:graphic>
          <a:graphicData uri="http://schemas.openxmlformats.org/presentationml/2006/ole">
            <p:oleObj progId="Excel.Sheet.12" r:id="rId11" spid="">
              <p:embed/>
              <p:pic>
                <p:nvPicPr>
                  <p:cNvPr id="52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727200" y="6372360"/>
                    <a:ext cx="6802200" cy="9792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3" name=""/>
          <p:cNvGraphicFramePr/>
          <p:nvPr/>
        </p:nvGraphicFramePr>
        <p:xfrm>
          <a:off x="682560" y="1332000"/>
          <a:ext cx="6834240" cy="4024080"/>
        </p:xfrm>
        <a:graphic>
          <a:graphicData uri="http://schemas.openxmlformats.org/presentationml/2006/ole">
            <p:oleObj progId="Excel.Sheet.12" r:id="rId13" spid="">
              <p:embed/>
              <p:pic>
                <p:nvPicPr>
                  <p:cNvPr id="54" name="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682560" y="1332000"/>
                    <a:ext cx="6834240" cy="4024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5" name=""/>
          <p:cNvSpPr/>
          <p:nvPr/>
        </p:nvSpPr>
        <p:spPr>
          <a:xfrm>
            <a:off x="317520" y="14763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17520" y="56530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17880" y="65898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17880" y="74534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17520" y="83898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17520" y="939024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15720" y="1032660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00080" y="11485440"/>
            <a:ext cx="8020080" cy="3930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400" spc="-1" strike="noStrike">
                <a:solidFill>
                  <a:srgbClr val="000000"/>
                </a:solidFill>
                <a:latin typeface="Arial"/>
              </a:rPr>
              <a:t>S4 Fig. Distribution plot of subgroup 3a, 3b, and 3c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Frequency distribution plots of intra-subgroup and inter-group distances for subgroup 3a, 3b, and 3c. Y axis represents the frequency counts in each bin. X axis represents the value of uncorrected pairwise distance. Dash lines indicated the border line at 0.3750 and 0.3950 (see description in main articl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A) An overall distance distribution of TTV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B) Distribution plot of intra-group distance between strains within subgroup 3a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C) Distribution plot of evolutionary distances that calculated by comparing subgroup 3a strains to other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D) Distribution plot of intra-group distance between strains within subgroup 3b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E) Distribution plot of evolutionary distances that calculated by comparing subgroup 3b strains to other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F) Distribution plot of intra-group distance between strains within subgroup 3c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G) Distribution plot of evolutionary distances that calculated by comparing subgroup 3c strains to other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-34308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*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e Y axis of (B) to (H) are not in accordance with actual proportion</a:t>
            </a: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0800000">
            <a:off x="316080" y="2412720"/>
            <a:ext cx="454680" cy="12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requency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774240" y="5213520"/>
            <a:ext cx="62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i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356080" y="1547640"/>
            <a:ext cx="262080" cy="9361800"/>
          </a:xfrm>
          <a:prstGeom prst="rect">
            <a:avLst/>
          </a:prstGeom>
          <a:noFill/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225440" y="1547640"/>
            <a:ext cx="6218280" cy="9361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2569680" y="811080"/>
            <a:ext cx="223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Within phylogenetic grou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8" name=""/>
          <p:cNvGrpSpPr/>
          <p:nvPr/>
        </p:nvGrpSpPr>
        <p:grpSpPr>
          <a:xfrm>
            <a:off x="5356080" y="900000"/>
            <a:ext cx="2086200" cy="288720"/>
            <a:chOff x="5356080" y="900000"/>
            <a:chExt cx="2086200" cy="288720"/>
          </a:xfrm>
        </p:grpSpPr>
        <p:grpSp>
          <p:nvGrpSpPr>
            <p:cNvPr id="69" name=""/>
            <p:cNvGrpSpPr/>
            <p:nvPr/>
          </p:nvGrpSpPr>
          <p:grpSpPr>
            <a:xfrm>
              <a:off x="5356080" y="1044360"/>
              <a:ext cx="2086200" cy="144360"/>
              <a:chOff x="5356080" y="1044360"/>
              <a:chExt cx="2086200" cy="144360"/>
            </a:xfrm>
          </p:grpSpPr>
          <p:sp>
            <p:nvSpPr>
              <p:cNvPr id="70" name=""/>
              <p:cNvSpPr/>
              <p:nvPr/>
            </p:nvSpPr>
            <p:spPr>
              <a:xfrm>
                <a:off x="5356080" y="1044360"/>
                <a:ext cx="208620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5356080" y="1044360"/>
                <a:ext cx="0" cy="14436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7442280" y="1044360"/>
                <a:ext cx="0" cy="14436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3" name=""/>
            <p:cNvSpPr/>
            <p:nvPr/>
          </p:nvSpPr>
          <p:spPr>
            <a:xfrm>
              <a:off x="6394680" y="900000"/>
              <a:ext cx="0" cy="1443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4" name=""/>
          <p:cNvGrpSpPr/>
          <p:nvPr/>
        </p:nvGrpSpPr>
        <p:grpSpPr>
          <a:xfrm>
            <a:off x="1251000" y="1189080"/>
            <a:ext cx="4388760" cy="288360"/>
            <a:chOff x="1251000" y="1189080"/>
            <a:chExt cx="4388760" cy="288360"/>
          </a:xfrm>
        </p:grpSpPr>
        <p:grpSp>
          <p:nvGrpSpPr>
            <p:cNvPr id="75" name=""/>
            <p:cNvGrpSpPr/>
            <p:nvPr/>
          </p:nvGrpSpPr>
          <p:grpSpPr>
            <a:xfrm>
              <a:off x="1251000" y="1333080"/>
              <a:ext cx="4388760" cy="144360"/>
              <a:chOff x="1251000" y="1333080"/>
              <a:chExt cx="4388760" cy="144360"/>
            </a:xfrm>
          </p:grpSpPr>
          <p:sp>
            <p:nvSpPr>
              <p:cNvPr id="76" name=""/>
              <p:cNvSpPr/>
              <p:nvPr/>
            </p:nvSpPr>
            <p:spPr>
              <a:xfrm>
                <a:off x="1251000" y="1333080"/>
                <a:ext cx="438876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1251000" y="1333080"/>
                <a:ext cx="0" cy="14436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5639760" y="1333080"/>
                <a:ext cx="0" cy="14436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9" name=""/>
            <p:cNvSpPr/>
            <p:nvPr/>
          </p:nvSpPr>
          <p:spPr>
            <a:xfrm>
              <a:off x="3436560" y="1189080"/>
              <a:ext cx="0" cy="1440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" name=""/>
          <p:cNvSpPr/>
          <p:nvPr/>
        </p:nvSpPr>
        <p:spPr>
          <a:xfrm>
            <a:off x="5278680" y="523800"/>
            <a:ext cx="243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etween phylogenetic grou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3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05T03:41:55Z</dcterms:created>
  <dc:creator> </dc:creator>
  <dc:description/>
  <dc:language>en-US</dc:language>
  <cp:lastModifiedBy> </cp:lastModifiedBy>
  <dcterms:modified xsi:type="dcterms:W3CDTF">2016-02-12T07:34:07Z</dcterms:modified>
  <cp:revision>44</cp:revision>
  <dc:subject/>
  <dc:title>投影片 1</dc:title>
</cp:coreProperties>
</file>